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29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56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7" Type="http://schemas.openxmlformats.org/officeDocument/2006/relationships/image" Target="../media/image3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w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60E6AD6D-D95E-498A-9A10-FBA27C4A96A9}"/>
              </a:ext>
            </a:extLst>
          </p:cNvPr>
          <p:cNvSpPr txBox="1"/>
          <p:nvPr/>
        </p:nvSpPr>
        <p:spPr>
          <a:xfrm>
            <a:off x="942915" y="384203"/>
            <a:ext cx="5390029" cy="26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TCGA Pan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Atlas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(32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, 10967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s-E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95CA5A06-7E6C-4994-BDF4-EF3C96AAA2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4755950"/>
              </p:ext>
            </p:extLst>
          </p:nvPr>
        </p:nvGraphicFramePr>
        <p:xfrm>
          <a:off x="1981830" y="870185"/>
          <a:ext cx="3381376" cy="2349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3878280" imgH="2694240" progId="">
                  <p:embed/>
                </p:oleObj>
              </mc:Choice>
              <mc:Fallback>
                <p:oleObj r:id="rId2" imgW="3878280" imgH="2694240" progId="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A966D91-FB9C-4CAF-8D01-EE75B15502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81830" y="870185"/>
                        <a:ext cx="3381376" cy="2349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DFA37AFE-396B-4585-8538-13736E2471AF}"/>
              </a:ext>
            </a:extLst>
          </p:cNvPr>
          <p:cNvSpPr txBox="1"/>
          <p:nvPr/>
        </p:nvSpPr>
        <p:spPr>
          <a:xfrm>
            <a:off x="2947703" y="825726"/>
            <a:ext cx="14265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CBX3 CNA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Logrank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1844C0E-B9AB-4180-ADF9-A8A36A9E4AF4}"/>
              </a:ext>
            </a:extLst>
          </p:cNvPr>
          <p:cNvSpPr txBox="1"/>
          <p:nvPr/>
        </p:nvSpPr>
        <p:spPr>
          <a:xfrm rot="16200000">
            <a:off x="4045638" y="1229760"/>
            <a:ext cx="815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**** 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981FBE3-E63E-41AA-959D-FFD6B8A35825}"/>
              </a:ext>
            </a:extLst>
          </p:cNvPr>
          <p:cNvCxnSpPr>
            <a:cxnSpLocks/>
          </p:cNvCxnSpPr>
          <p:nvPr/>
        </p:nvCxnSpPr>
        <p:spPr>
          <a:xfrm>
            <a:off x="4324997" y="1130639"/>
            <a:ext cx="0" cy="4374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9B078011-0061-4C95-9C77-BB40D15FCD97}"/>
              </a:ext>
            </a:extLst>
          </p:cNvPr>
          <p:cNvSpPr txBox="1"/>
          <p:nvPr/>
        </p:nvSpPr>
        <p:spPr>
          <a:xfrm>
            <a:off x="3016467" y="1169428"/>
            <a:ext cx="6557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7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8C715ED-5DD5-400E-A497-216F63E02509}"/>
              </a:ext>
            </a:extLst>
          </p:cNvPr>
          <p:cNvSpPr txBox="1"/>
          <p:nvPr/>
        </p:nvSpPr>
        <p:spPr>
          <a:xfrm>
            <a:off x="3018209" y="1374397"/>
            <a:ext cx="6557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602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31C4CCE-AFA2-4E92-BA70-5BB74678FE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0691345"/>
              </p:ext>
            </p:extLst>
          </p:nvPr>
        </p:nvGraphicFramePr>
        <p:xfrm>
          <a:off x="1946449" y="3846380"/>
          <a:ext cx="3382962" cy="2349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3878280" imgH="2694240" progId="">
                  <p:embed/>
                </p:oleObj>
              </mc:Choice>
              <mc:Fallback>
                <p:oleObj r:id="rId4" imgW="3878280" imgH="26942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46449" y="3846380"/>
                        <a:ext cx="3382962" cy="2349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TextBox 41">
            <a:extLst>
              <a:ext uri="{FF2B5EF4-FFF2-40B4-BE49-F238E27FC236}">
                <a16:creationId xmlns:a16="http://schemas.microsoft.com/office/drawing/2014/main" id="{DD762678-4C5F-4B29-9AAB-DDB35B54A9AD}"/>
              </a:ext>
            </a:extLst>
          </p:cNvPr>
          <p:cNvSpPr txBox="1"/>
          <p:nvPr/>
        </p:nvSpPr>
        <p:spPr>
          <a:xfrm rot="16200000">
            <a:off x="-197694" y="4819507"/>
            <a:ext cx="23262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isease-specific</a:t>
            </a:r>
            <a:r>
              <a:rPr lang="es-E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es-E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4249005-A502-4218-BBB3-054CFB88A2D5}"/>
              </a:ext>
            </a:extLst>
          </p:cNvPr>
          <p:cNvSpPr txBox="1"/>
          <p:nvPr/>
        </p:nvSpPr>
        <p:spPr>
          <a:xfrm>
            <a:off x="3090121" y="3671746"/>
            <a:ext cx="14265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CBX3 CNA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Logrank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7E22C1A-16C6-4D20-932C-E654ECA2E768}"/>
              </a:ext>
            </a:extLst>
          </p:cNvPr>
          <p:cNvSpPr txBox="1"/>
          <p:nvPr/>
        </p:nvSpPr>
        <p:spPr>
          <a:xfrm rot="16200000">
            <a:off x="4188056" y="4075780"/>
            <a:ext cx="815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01*** 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01E8863F-C8D7-490D-BF6D-0FAA723D2028}"/>
              </a:ext>
            </a:extLst>
          </p:cNvPr>
          <p:cNvCxnSpPr>
            <a:cxnSpLocks/>
          </p:cNvCxnSpPr>
          <p:nvPr/>
        </p:nvCxnSpPr>
        <p:spPr>
          <a:xfrm>
            <a:off x="4467415" y="3976659"/>
            <a:ext cx="0" cy="4374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AACCA6CA-2DED-45A8-B4D6-46B9ECC50D4D}"/>
              </a:ext>
            </a:extLst>
          </p:cNvPr>
          <p:cNvSpPr txBox="1"/>
          <p:nvPr/>
        </p:nvSpPr>
        <p:spPr>
          <a:xfrm>
            <a:off x="3158885" y="4015448"/>
            <a:ext cx="6557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5C9CC7-1D45-49CA-B692-734E3985B68A}"/>
              </a:ext>
            </a:extLst>
          </p:cNvPr>
          <p:cNvSpPr txBox="1"/>
          <p:nvPr/>
        </p:nvSpPr>
        <p:spPr>
          <a:xfrm>
            <a:off x="3160627" y="4220417"/>
            <a:ext cx="6557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560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DFC0D30A-2A52-4656-945D-7806EC7DC6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8281090"/>
              </p:ext>
            </p:extLst>
          </p:nvPr>
        </p:nvGraphicFramePr>
        <p:xfrm>
          <a:off x="1901999" y="6787004"/>
          <a:ext cx="3471862" cy="2411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3878280" imgH="2694240" progId="">
                  <p:embed/>
                </p:oleObj>
              </mc:Choice>
              <mc:Fallback>
                <p:oleObj r:id="rId6" imgW="3878280" imgH="26942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901999" y="6787004"/>
                        <a:ext cx="3471862" cy="2411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TextBox 47">
            <a:extLst>
              <a:ext uri="{FF2B5EF4-FFF2-40B4-BE49-F238E27FC236}">
                <a16:creationId xmlns:a16="http://schemas.microsoft.com/office/drawing/2014/main" id="{F63E3E24-6848-4ECF-A7A8-2BCF3665A690}"/>
              </a:ext>
            </a:extLst>
          </p:cNvPr>
          <p:cNvSpPr txBox="1"/>
          <p:nvPr/>
        </p:nvSpPr>
        <p:spPr>
          <a:xfrm rot="16200000">
            <a:off x="-207051" y="7736778"/>
            <a:ext cx="23262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rogression</a:t>
            </a:r>
            <a:r>
              <a:rPr lang="es-E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-free </a:t>
            </a:r>
            <a:r>
              <a:rPr lang="es-E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es-E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EBA3357-75BD-412E-AC4B-D72DADDE36AE}"/>
              </a:ext>
            </a:extLst>
          </p:cNvPr>
          <p:cNvSpPr txBox="1"/>
          <p:nvPr/>
        </p:nvSpPr>
        <p:spPr>
          <a:xfrm>
            <a:off x="2819267" y="6556172"/>
            <a:ext cx="14265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CBX3 CNA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Logrank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D595511-70B3-4788-8166-D545B9B7D3B1}"/>
              </a:ext>
            </a:extLst>
          </p:cNvPr>
          <p:cNvSpPr txBox="1"/>
          <p:nvPr/>
        </p:nvSpPr>
        <p:spPr>
          <a:xfrm rot="16200000">
            <a:off x="4123411" y="7081145"/>
            <a:ext cx="815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1** 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1C77894-EA25-4AC1-B7EB-64CF560ECD5B}"/>
              </a:ext>
            </a:extLst>
          </p:cNvPr>
          <p:cNvCxnSpPr>
            <a:cxnSpLocks/>
          </p:cNvCxnSpPr>
          <p:nvPr/>
        </p:nvCxnSpPr>
        <p:spPr>
          <a:xfrm>
            <a:off x="4402770" y="6982024"/>
            <a:ext cx="0" cy="4374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77E94CA6-A8DC-400E-995B-E181533A60D8}"/>
              </a:ext>
            </a:extLst>
          </p:cNvPr>
          <p:cNvSpPr txBox="1"/>
          <p:nvPr/>
        </p:nvSpPr>
        <p:spPr>
          <a:xfrm>
            <a:off x="3053047" y="7034395"/>
            <a:ext cx="6557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9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576800C-531F-4990-92A6-91A715F7E83C}"/>
              </a:ext>
            </a:extLst>
          </p:cNvPr>
          <p:cNvSpPr txBox="1"/>
          <p:nvPr/>
        </p:nvSpPr>
        <p:spPr>
          <a:xfrm>
            <a:off x="3054789" y="7239364"/>
            <a:ext cx="6557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55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B7115BE-E796-49E4-ADE3-CE51D7AF7F69}"/>
              </a:ext>
            </a:extLst>
          </p:cNvPr>
          <p:cNvSpPr txBox="1"/>
          <p:nvPr/>
        </p:nvSpPr>
        <p:spPr>
          <a:xfrm rot="16200000">
            <a:off x="191060" y="1760474"/>
            <a:ext cx="13096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Overall</a:t>
            </a:r>
            <a:r>
              <a:rPr lang="es-E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es-E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8CB81-A580-4A16-AD4F-0FEDB69D2CC5}"/>
              </a:ext>
            </a:extLst>
          </p:cNvPr>
          <p:cNvSpPr txBox="1"/>
          <p:nvPr/>
        </p:nvSpPr>
        <p:spPr>
          <a:xfrm>
            <a:off x="413190" y="616830"/>
            <a:ext cx="6298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7C10AB9-48FC-4951-8FD8-943D03773B86}"/>
              </a:ext>
            </a:extLst>
          </p:cNvPr>
          <p:cNvSpPr txBox="1"/>
          <p:nvPr/>
        </p:nvSpPr>
        <p:spPr>
          <a:xfrm>
            <a:off x="400178" y="3814169"/>
            <a:ext cx="6298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B87F606-6F84-4B97-94DC-2D2D29E49211}"/>
              </a:ext>
            </a:extLst>
          </p:cNvPr>
          <p:cNvSpPr txBox="1"/>
          <p:nvPr/>
        </p:nvSpPr>
        <p:spPr>
          <a:xfrm>
            <a:off x="459006" y="6470753"/>
            <a:ext cx="6298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022299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66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7:23Z</dcterms:modified>
</cp:coreProperties>
</file>